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57A6A-7299-4363-AFDA-28B3385661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BD181-EC98-4D19-99BA-A2EBEE08F6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ED631-9E03-46D9-B73D-3346EC5991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EAC501-6EE3-4821-88F3-F7CADB3728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E3933-9C5C-4041-9A47-0A5BEDDEDD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DF728-9526-44B2-9B04-75872447C1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CC78DE-17B9-493B-8FBE-D573043DBF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A21EB-68EB-40B3-AD0C-2F7B859D33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F83CB-F90D-4F6C-95C3-E592450A31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03586A-1DCD-490F-A2E2-DFEAED2CCD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6FB9E5-03F3-4F4D-89F1-E92B3F5DE6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3D671-7565-4FEC-A689-E15BFDD32D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8D8F77-1FB8-46A4-BF25-6B76073C8FDB}" type="slidenum">
              <a: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412160" y="1185840"/>
            <a:ext cx="110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TR Locu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55600" y="1725480"/>
            <a:ext cx="96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ell li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365480" y="1727280"/>
            <a:ext cx="68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M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984320" y="1727280"/>
            <a:ext cx="89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SF1P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837160" y="1727280"/>
            <a:ext cx="92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13S3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670560" y="1727280"/>
            <a:ext cx="92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16S53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572720" y="1727280"/>
            <a:ext cx="82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5S8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265000" y="1727280"/>
            <a:ext cx="82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7S8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100200" y="1727280"/>
            <a:ext cx="61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415640" y="1727280"/>
            <a:ext cx="57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vW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696000" y="172728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PO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902000" y="1397160"/>
            <a:ext cx="9730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erc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atch to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e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013120" y="1623960"/>
            <a:ext cx="5905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85840" y="4883040"/>
            <a:ext cx="86407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85840" y="2185920"/>
            <a:ext cx="86407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85840" y="1052640"/>
            <a:ext cx="86407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31840" y="690480"/>
            <a:ext cx="634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1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mparison between STR profiles of HeLa and its subline HeLaS3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324000" y="2205000"/>
          <a:ext cx="8496000" cy="2717640"/>
        </p:xfrm>
        <a:graphic>
          <a:graphicData uri="http://schemas.openxmlformats.org/drawingml/2006/table">
            <a:tbl>
              <a:tblPr/>
              <a:tblGrid>
                <a:gridCol w="936360"/>
                <a:gridCol w="649440"/>
                <a:gridCol w="853920"/>
                <a:gridCol w="889200"/>
                <a:gridCol w="865080"/>
                <a:gridCol w="757440"/>
                <a:gridCol w="757080"/>
                <a:gridCol w="649440"/>
                <a:gridCol w="647640"/>
                <a:gridCol w="841320"/>
                <a:gridCol w="649080"/>
              </a:tblGrid>
              <a:tr h="6256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L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,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2,13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,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1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,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256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LaS3/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CCL2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,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3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,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1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,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733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LaS3/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IF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500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,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2,13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,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7,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733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HeLaS3/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JCR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0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,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3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,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1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,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6,17,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9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9" name=""/>
          <p:cNvSpPr/>
          <p:nvPr/>
        </p:nvSpPr>
        <p:spPr>
          <a:xfrm>
            <a:off x="151560" y="4998960"/>
            <a:ext cx="8922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TR profiling of HeLa was compared to data in the JCRB database (HeLaS3/CCL2.2, HeLaS3/IFO50011, an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LaS3/JCRB9010)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28T19:31:18Z</dcterms:created>
  <dc:creator>otetsu</dc:creator>
  <dc:description/>
  <dc:language>en-US</dc:language>
  <cp:lastModifiedBy>otetsu</cp:lastModifiedBy>
  <dcterms:modified xsi:type="dcterms:W3CDTF">2009-05-27T20:29:10Z</dcterms:modified>
  <cp:revision>77</cp:revision>
  <dc:subject/>
  <dc:title>Slide 1</dc:title>
</cp:coreProperties>
</file>